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BE34EE-3CC3-4851-886E-2FC63D28C86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44E081-A1C7-4B9B-8807-F90E13FBA3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91DB53-B5D4-484A-A6E9-B46181E6517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8F2831-D477-48F9-B556-636DB452424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A75332-24F2-478F-8923-9317293300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0D4D5C-B668-4E54-8F56-3A77ED2BAA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7625CD-2496-4FD9-BFEE-F9140DA404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38EB62-9910-4E39-A815-EA77291757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2E8208-D4A5-4BD2-9863-97ED89EC67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9109D8-D375-46D3-A200-333FED6F0B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36A21C-8B0D-448E-8741-D946CAB013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B0A847-6479-4936-BA8F-C8DD34CCCE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BD05AAA-489B-442E-8328-9BADE6B0259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"/>
          <p:cNvGrpSpPr/>
          <p:nvPr/>
        </p:nvGrpSpPr>
        <p:grpSpPr>
          <a:xfrm>
            <a:off x="1371600" y="952560"/>
            <a:ext cx="3886200" cy="3242520"/>
            <a:chOff x="1371600" y="952560"/>
            <a:chExt cx="3886200" cy="3242520"/>
          </a:xfrm>
        </p:grpSpPr>
        <p:pic>
          <p:nvPicPr>
            <p:cNvPr id="42" name="Object 2" descr=""/>
            <p:cNvPicPr/>
            <p:nvPr/>
          </p:nvPicPr>
          <p:blipFill>
            <a:blip r:embed="rId1"/>
            <a:stretch/>
          </p:blipFill>
          <p:spPr>
            <a:xfrm>
              <a:off x="1471680" y="952560"/>
              <a:ext cx="3786120" cy="3102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Box 1"/>
            <p:cNvSpPr/>
            <p:nvPr/>
          </p:nvSpPr>
          <p:spPr>
            <a:xfrm rot="16200000">
              <a:off x="348840" y="2177280"/>
              <a:ext cx="229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Log expression level (real-time RT-PCR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Box 4"/>
            <p:cNvSpPr/>
            <p:nvPr/>
          </p:nvSpPr>
          <p:spPr>
            <a:xfrm>
              <a:off x="2423160" y="3948840"/>
              <a:ext cx="1918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Log expression level (microarray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5" name="Rectangle 400"/>
          <p:cNvSpPr/>
          <p:nvPr/>
        </p:nvSpPr>
        <p:spPr>
          <a:xfrm>
            <a:off x="685800" y="4815360"/>
            <a:ext cx="5730840" cy="105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dditional file 6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Validation of the expression of 15 selected genes representing OsDREB1 regulon and candidate genes of introgressed segments by qRT-PCR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orrelation analysis shows a good agreement between microarray and qRT-RCR experiments. The gene expression values were transformed to log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scale. The microarray data log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-value (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X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-axis) were plotted against the qRT-PCR log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-value (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Y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-axis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Fan Zhang</dc:creator>
  <dc:description/>
  <dc:language>en-US</dc:language>
  <cp:lastModifiedBy>Fan</cp:lastModifiedBy>
  <dcterms:modified xsi:type="dcterms:W3CDTF">2012-08-01T08:45:00Z</dcterms:modified>
  <cp:revision>17</cp:revision>
  <dc:subject/>
  <dc:title>PowerPoint Presentation</dc:title>
</cp:coreProperties>
</file>